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0"/>
  </p:notesMasterIdLst>
  <p:sldIdLst>
    <p:sldId id="256" r:id="rId5"/>
    <p:sldId id="273" r:id="rId6"/>
    <p:sldId id="270" r:id="rId7"/>
    <p:sldId id="272" r:id="rId8"/>
    <p:sldId id="274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2" autoAdjust="0"/>
    <p:restoredTop sz="94660"/>
  </p:normalViewPr>
  <p:slideViewPr>
    <p:cSldViewPr snapToGrid="0">
      <p:cViewPr>
        <p:scale>
          <a:sx n="70" d="100"/>
          <a:sy n="70" d="100"/>
        </p:scale>
        <p:origin x="930" y="7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6/11/relationships/changesInfo" Target="changesInfos/changesInfo1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k" userId="2701c67b-d932-4141-b195-fa3b5daf655c" providerId="ADAL" clId="{F1C21FBC-00BF-4A7B-B94E-8AB99134A402}"/>
    <pc:docChg chg="undo custSel modSld">
      <pc:chgData name="Mark" userId="2701c67b-d932-4141-b195-fa3b5daf655c" providerId="ADAL" clId="{F1C21FBC-00BF-4A7B-B94E-8AB99134A402}" dt="2020-08-28T10:25:34.461" v="110" actId="1076"/>
      <pc:docMkLst>
        <pc:docMk/>
      </pc:docMkLst>
      <pc:sldChg chg="modSp mod">
        <pc:chgData name="Mark" userId="2701c67b-d932-4141-b195-fa3b5daf655c" providerId="ADAL" clId="{F1C21FBC-00BF-4A7B-B94E-8AB99134A402}" dt="2020-08-28T10:25:34.461" v="110" actId="1076"/>
        <pc:sldMkLst>
          <pc:docMk/>
          <pc:sldMk cId="1835941021" sldId="256"/>
        </pc:sldMkLst>
        <pc:spChg chg="mod">
          <ac:chgData name="Mark" userId="2701c67b-d932-4141-b195-fa3b5daf655c" providerId="ADAL" clId="{F1C21FBC-00BF-4A7B-B94E-8AB99134A402}" dt="2020-08-28T10:25:34.461" v="110" actId="1076"/>
          <ac:spMkLst>
            <pc:docMk/>
            <pc:sldMk cId="1835941021" sldId="256"/>
            <ac:spMk id="3" creationId="{186B6245-4D4C-4B89-AACA-924DE5BE19C7}"/>
          </ac:spMkLst>
        </pc:spChg>
      </pc:sldChg>
      <pc:sldChg chg="modSp mod">
        <pc:chgData name="Mark" userId="2701c67b-d932-4141-b195-fa3b5daf655c" providerId="ADAL" clId="{F1C21FBC-00BF-4A7B-B94E-8AB99134A402}" dt="2020-08-28T10:23:42.336" v="81" actId="20577"/>
        <pc:sldMkLst>
          <pc:docMk/>
          <pc:sldMk cId="63804338" sldId="270"/>
        </pc:sldMkLst>
        <pc:spChg chg="mod">
          <ac:chgData name="Mark" userId="2701c67b-d932-4141-b195-fa3b5daf655c" providerId="ADAL" clId="{F1C21FBC-00BF-4A7B-B94E-8AB99134A402}" dt="2020-08-28T10:23:42.336" v="81" actId="20577"/>
          <ac:spMkLst>
            <pc:docMk/>
            <pc:sldMk cId="63804338" sldId="270"/>
            <ac:spMk id="3" creationId="{00000000-0000-0000-0000-000000000000}"/>
          </ac:spMkLst>
        </pc:spChg>
        <pc:picChg chg="mod">
          <ac:chgData name="Mark" userId="2701c67b-d932-4141-b195-fa3b5daf655c" providerId="ADAL" clId="{F1C21FBC-00BF-4A7B-B94E-8AB99134A402}" dt="2020-08-28T10:23:12.391" v="64" actId="1076"/>
          <ac:picMkLst>
            <pc:docMk/>
            <pc:sldMk cId="63804338" sldId="270"/>
            <ac:picMk id="4" creationId="{154D32C9-4468-40EE-8FC2-8DDA001CD0CB}"/>
          </ac:picMkLst>
        </pc:picChg>
      </pc:sldChg>
      <pc:sldChg chg="modSp mod">
        <pc:chgData name="Mark" userId="2701c67b-d932-4141-b195-fa3b5daf655c" providerId="ADAL" clId="{F1C21FBC-00BF-4A7B-B94E-8AB99134A402}" dt="2020-08-28T10:23:38.896" v="78" actId="20577"/>
        <pc:sldMkLst>
          <pc:docMk/>
          <pc:sldMk cId="1578314814" sldId="272"/>
        </pc:sldMkLst>
        <pc:spChg chg="mod">
          <ac:chgData name="Mark" userId="2701c67b-d932-4141-b195-fa3b5daf655c" providerId="ADAL" clId="{F1C21FBC-00BF-4A7B-B94E-8AB99134A402}" dt="2020-08-28T10:23:38.896" v="78" actId="20577"/>
          <ac:spMkLst>
            <pc:docMk/>
            <pc:sldMk cId="1578314814" sldId="272"/>
            <ac:spMk id="3" creationId="{ACD7561F-4F9C-4460-BDD2-BA304CD53BE7}"/>
          </ac:spMkLst>
        </pc:spChg>
        <pc:picChg chg="mod">
          <ac:chgData name="Mark" userId="2701c67b-d932-4141-b195-fa3b5daf655c" providerId="ADAL" clId="{F1C21FBC-00BF-4A7B-B94E-8AB99134A402}" dt="2020-08-28T10:23:29.942" v="74" actId="1076"/>
          <ac:picMkLst>
            <pc:docMk/>
            <pc:sldMk cId="1578314814" sldId="272"/>
            <ac:picMk id="4" creationId="{A5C0D994-7975-49E1-A884-C8D787809DAF}"/>
          </ac:picMkLst>
        </pc:picChg>
      </pc:sldChg>
      <pc:sldChg chg="modSp mod">
        <pc:chgData name="Mark" userId="2701c67b-d932-4141-b195-fa3b5daf655c" providerId="ADAL" clId="{F1C21FBC-00BF-4A7B-B94E-8AB99134A402}" dt="2020-08-28T10:22:54.868" v="57" actId="122"/>
        <pc:sldMkLst>
          <pc:docMk/>
          <pc:sldMk cId="2211760976" sldId="273"/>
        </pc:sldMkLst>
        <pc:spChg chg="mod">
          <ac:chgData name="Mark" userId="2701c67b-d932-4141-b195-fa3b5daf655c" providerId="ADAL" clId="{F1C21FBC-00BF-4A7B-B94E-8AB99134A402}" dt="2020-08-28T10:22:54.868" v="57" actId="122"/>
          <ac:spMkLst>
            <pc:docMk/>
            <pc:sldMk cId="2211760976" sldId="273"/>
            <ac:spMk id="3" creationId="{536D3E58-32F7-4AAA-911B-439112C90235}"/>
          </ac:spMkLst>
        </pc:spChg>
        <pc:picChg chg="mod">
          <ac:chgData name="Mark" userId="2701c67b-d932-4141-b195-fa3b5daf655c" providerId="ADAL" clId="{F1C21FBC-00BF-4A7B-B94E-8AB99134A402}" dt="2020-08-28T10:22:09.158" v="31" actId="1076"/>
          <ac:picMkLst>
            <pc:docMk/>
            <pc:sldMk cId="2211760976" sldId="273"/>
            <ac:picMk id="7" creationId="{8A1C4017-A098-44C2-A93A-9D8317604034}"/>
          </ac:picMkLst>
        </pc:picChg>
      </pc:sldChg>
      <pc:sldChg chg="modSp mod">
        <pc:chgData name="Mark" userId="2701c67b-d932-4141-b195-fa3b5daf655c" providerId="ADAL" clId="{F1C21FBC-00BF-4A7B-B94E-8AB99134A402}" dt="2020-08-28T10:24:14.429" v="87" actId="1076"/>
        <pc:sldMkLst>
          <pc:docMk/>
          <pc:sldMk cId="3378125998" sldId="274"/>
        </pc:sldMkLst>
        <pc:spChg chg="mod">
          <ac:chgData name="Mark" userId="2701c67b-d932-4141-b195-fa3b5daf655c" providerId="ADAL" clId="{F1C21FBC-00BF-4A7B-B94E-8AB99134A402}" dt="2020-08-28T10:23:49.569" v="84" actId="122"/>
          <ac:spMkLst>
            <pc:docMk/>
            <pc:sldMk cId="3378125998" sldId="274"/>
            <ac:spMk id="2" creationId="{C9D35A65-FC38-4CE7-965F-4AD8B69A087C}"/>
          </ac:spMkLst>
        </pc:spChg>
        <pc:picChg chg="mod">
          <ac:chgData name="Mark" userId="2701c67b-d932-4141-b195-fa3b5daf655c" providerId="ADAL" clId="{F1C21FBC-00BF-4A7B-B94E-8AB99134A402}" dt="2020-08-28T10:24:14.429" v="87" actId="1076"/>
          <ac:picMkLst>
            <pc:docMk/>
            <pc:sldMk cId="3378125998" sldId="274"/>
            <ac:picMk id="7" creationId="{5FED41F4-C124-4E54-BA03-32DBC8B04195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0B4EF9-52F9-430F-B7B5-3691EF926E7E}" type="datetimeFigureOut">
              <a:rPr lang="en-GB" smtClean="0"/>
              <a:t>28/08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F6A6FC-1F93-48F9-9DCA-9B4DB9F7F99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57191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He underwent coronary angiography – which even to the untrained eye clearly shows dilatation of the coronary arterie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8FBBFA-59A8-4223-AC0D-6DCF81D7EFCB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34695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Here catherization of the left coronary circulation Is made</a:t>
            </a:r>
          </a:p>
          <a:p>
            <a:r>
              <a:rPr lang="en-GB" dirty="0"/>
              <a:t>Should see blood/contrast flow </a:t>
            </a:r>
          </a:p>
          <a:p>
            <a:r>
              <a:rPr lang="en-GB" dirty="0"/>
              <a:t>Absence indicates blockage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8FBBFA-59A8-4223-AC0D-6DCF81D7EFCB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886853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Interventional cardiology team: performed clot aspiration with intra-coronary thrombolysis</a:t>
            </a:r>
          </a:p>
          <a:p>
            <a:r>
              <a:rPr lang="en-GB" dirty="0"/>
              <a:t>Able to relive the obstruction &amp; restore circulation.</a:t>
            </a:r>
          </a:p>
          <a:p>
            <a:r>
              <a:rPr lang="en-GB" dirty="0"/>
              <a:t>No stent /metal work left in place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8FBBFA-59A8-4223-AC0D-6DCF81D7EFCB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0991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3EAF04-DCE1-4DDC-88B8-536BC4A417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5194F66-02AB-483F-8B6F-6823052405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27AA78-0A81-449D-B97C-04FFB1602F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E9749-AB1F-4A07-885B-BBF545A1BC61}" type="datetimeFigureOut">
              <a:rPr lang="en-GB" smtClean="0"/>
              <a:t>28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5354F6-6159-4791-AF56-65F403869C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C2B36A-00C2-4427-A27C-543DFEE5CD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11BA-6BF8-483F-93E3-30F467F9B7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12195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90CEDD-CF6B-4B90-BD79-702230AA85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2155FF-9D9A-41E1-8C75-3D80771FD7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B64E8B-0093-4551-9D40-0F2A657DFE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E9749-AB1F-4A07-885B-BBF545A1BC61}" type="datetimeFigureOut">
              <a:rPr lang="en-GB" smtClean="0"/>
              <a:t>28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E66400-CF75-4E5F-ABCD-8E52D2AE0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48B135-D0CC-442A-AD90-4934A383CA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11BA-6BF8-483F-93E3-30F467F9B7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21371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077E882-2522-4D1E-A525-CE3BF53B46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A1BD1A2-4C6C-404E-8DCF-5B028DAA3F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961B11-D4F1-4688-B403-3697A276C7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E9749-AB1F-4A07-885B-BBF545A1BC61}" type="datetimeFigureOut">
              <a:rPr lang="en-GB" smtClean="0"/>
              <a:t>28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3BBFF5-0599-414F-B730-382839E532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88974F-137C-4B30-A6AB-EF96CD420E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11BA-6BF8-483F-93E3-30F467F9B7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13283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1B7ADA-05C6-4BE6-A5E7-1358C3B3EB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A5BC04-8288-4C10-AEA5-95085A6D75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E8306F-512A-4056-9F66-E8EBD521E6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E9749-AB1F-4A07-885B-BBF545A1BC61}" type="datetimeFigureOut">
              <a:rPr lang="en-GB" smtClean="0"/>
              <a:t>28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240EFF-6B7B-4BF0-ACFA-3A1029568B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61F695-2AA1-487E-A5A1-E30800D470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11BA-6BF8-483F-93E3-30F467F9B7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1188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A61074-467F-45B8-B011-33298B96BA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D519A5-51F0-45BF-8F6D-37AB246F01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C66831-A25F-4B05-94EC-90C6CFBF36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E9749-AB1F-4A07-885B-BBF545A1BC61}" type="datetimeFigureOut">
              <a:rPr lang="en-GB" smtClean="0"/>
              <a:t>28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29053E-7082-4ECE-8A73-B2F7A80EE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3CD48A-4366-4267-BA30-A61E6C4684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11BA-6BF8-483F-93E3-30F467F9B7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4107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E0BDEF-EC09-4384-9E6D-33C9F0F082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D165B3-49A1-47D7-8F02-5974039C20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1AA80E2-03F2-4C21-9468-01DEBD28E0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2E454C-D913-4E18-A673-26C63D9427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E9749-AB1F-4A07-885B-BBF545A1BC61}" type="datetimeFigureOut">
              <a:rPr lang="en-GB" smtClean="0"/>
              <a:t>28/08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6E816A-FA4E-497C-8483-CADC9E0B40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8A4342-3F1C-4738-8D22-F8AB27DACD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11BA-6BF8-483F-93E3-30F467F9B7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89657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140FCB-AB7D-486C-93DA-37E6562592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978474-E254-41BB-BDE8-4F33FB0D2B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3A364C-5386-41FE-BC1B-B974FA2CA8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8F7EFEA-EAA0-465D-B654-905065478FE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8159AE5-20FC-4DCD-B10D-CD9AF2EA2E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6D921A5-0F97-4C24-B47A-4C5982655B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E9749-AB1F-4A07-885B-BBF545A1BC61}" type="datetimeFigureOut">
              <a:rPr lang="en-GB" smtClean="0"/>
              <a:t>28/08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2304E5A-85D1-4EED-8EB4-CE80CE382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EC08C22-42E8-4942-8330-675B3AEDC5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11BA-6BF8-483F-93E3-30F467F9B7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65130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08D834-1E20-4EAF-AC08-DE1588D5E0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4C9C798-65D2-4A4F-A32A-A2998378B7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E9749-AB1F-4A07-885B-BBF545A1BC61}" type="datetimeFigureOut">
              <a:rPr lang="en-GB" smtClean="0"/>
              <a:t>28/08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05E550C-54E5-43FA-81C4-9B1274AA1F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90C4CFE-B892-4042-ACDC-C95D61E61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11BA-6BF8-483F-93E3-30F467F9B7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2155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11896AD-CFE9-42AA-9CC8-DDCDC19E59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E9749-AB1F-4A07-885B-BBF545A1BC61}" type="datetimeFigureOut">
              <a:rPr lang="en-GB" smtClean="0"/>
              <a:t>28/08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DB2152B-D1BE-4559-A2E5-38311E674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CBFEB68-3A6E-4AFE-8120-0FA82F7E83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11BA-6BF8-483F-93E3-30F467F9B7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53483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CFDDBA-D667-4C38-A5ED-0EEAA197A4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908450-FFDE-47C1-B6A3-EBCD1F63AD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7DF6CA-D206-44AB-B251-A9B649FED9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51673E-0FA2-48FE-8314-C9F442ABE5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E9749-AB1F-4A07-885B-BBF545A1BC61}" type="datetimeFigureOut">
              <a:rPr lang="en-GB" smtClean="0"/>
              <a:t>28/08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A82CA7-30A6-4218-928D-8B1925BEC2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8BEBD7-463F-4E4A-9C7A-9B768E86F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11BA-6BF8-483F-93E3-30F467F9B7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65140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47C45A-A984-4B0B-B142-B43D5715B7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A2B645C-C7B8-4B1C-97F9-0BF64249C2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406608-6025-4B1D-932B-C50C970F7F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09CF80-F786-437A-A27D-4C28C49CAE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E9749-AB1F-4A07-885B-BBF545A1BC61}" type="datetimeFigureOut">
              <a:rPr lang="en-GB" smtClean="0"/>
              <a:t>28/08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E33DBE-174A-4F24-AAC3-7786B9CA32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0A863A-DB00-4AC4-ACC8-F5228547F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D311BA-6BF8-483F-93E3-30F467F9B7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6749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A0966E-BDC7-4DE6-A237-E4DC23CF95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63F19D-EBE1-4D50-AA4A-64238AAD4E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4B6A40-FAD1-4390-98A6-10A0F39E61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9E9749-AB1F-4A07-885B-BBF545A1BC61}" type="datetimeFigureOut">
              <a:rPr lang="en-GB" smtClean="0"/>
              <a:t>28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996A2B-8AE8-4A15-8EFD-ADD23E4177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8E02D0-2226-45BE-9215-4C3B7E19B5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D311BA-6BF8-483F-93E3-30F467F9B7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07623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1.png"/><Relationship Id="rId4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5" Type="http://schemas.openxmlformats.org/officeDocument/2006/relationships/image" Target="../media/image2.png"/><Relationship Id="rId4" Type="http://schemas.openxmlformats.org/officeDocument/2006/relationships/notesSlide" Target="../notesSlides/notesSlide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5" Type="http://schemas.openxmlformats.org/officeDocument/2006/relationships/image" Target="../media/image3.png"/><Relationship Id="rId4" Type="http://schemas.openxmlformats.org/officeDocument/2006/relationships/notesSlide" Target="../notesSlides/notesSlide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BB27E8-3154-4B58-B2C3-3CF777F9600B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dirty="0"/>
              <a:t>Supplementary video fil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86B6245-4D4C-4B89-AACA-924DE5BE19C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509963"/>
            <a:ext cx="9144000" cy="2518983"/>
          </a:xfrm>
        </p:spPr>
        <p:txBody>
          <a:bodyPr>
            <a:normAutofit/>
          </a:bodyPr>
          <a:lstStyle/>
          <a:p>
            <a:r>
              <a:rPr lang="en-US" b="1" dirty="0"/>
              <a:t>Hematopoietic Stem Cell Transplantation and vasculopathy associated with STAT3-dominant-negative Hyper-IgE syndrome</a:t>
            </a:r>
            <a:endParaRPr lang="en-GB" b="1" dirty="0"/>
          </a:p>
          <a:p>
            <a:r>
              <a:rPr lang="en-GB" dirty="0"/>
              <a:t>MJ Ponsford et al.</a:t>
            </a:r>
          </a:p>
          <a:p>
            <a:r>
              <a:rPr lang="en-GB" sz="1800" b="0" i="1" u="none" strike="noStrike" baseline="0" dirty="0">
                <a:latin typeface="HelveticaNeueLTStd-LtIt"/>
              </a:rPr>
              <a:t>Front. </a:t>
            </a:r>
            <a:r>
              <a:rPr lang="en-GB" sz="1800" b="0" i="1" u="none" strike="noStrike" baseline="0" dirty="0" err="1">
                <a:latin typeface="HelveticaNeueLTStd-LtIt"/>
              </a:rPr>
              <a:t>Pediatr</a:t>
            </a:r>
            <a:r>
              <a:rPr lang="en-GB" sz="1800" b="0" i="1" u="none" strike="noStrike" baseline="0" dirty="0">
                <a:latin typeface="HelveticaNeueLTStd-LtIt"/>
              </a:rPr>
              <a:t>. 8:575. </a:t>
            </a:r>
            <a:r>
              <a:rPr lang="en-GB" sz="1800" b="0" i="1" u="none" strike="noStrike" baseline="0" dirty="0" err="1">
                <a:latin typeface="HelveticaNeueLTStd-LtIt"/>
              </a:rPr>
              <a:t>doi</a:t>
            </a:r>
            <a:r>
              <a:rPr lang="en-GB" sz="1800" b="0" i="1" u="none" strike="noStrike" baseline="0" dirty="0">
                <a:latin typeface="HelveticaNeueLTStd-LtIt"/>
              </a:rPr>
              <a:t>: 10.3389/fped.2020.0057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359410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id="{536D3E58-32F7-4AAA-911B-439112C902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426" y="77569"/>
            <a:ext cx="11980723" cy="1325563"/>
          </a:xfrm>
        </p:spPr>
        <p:txBody>
          <a:bodyPr>
            <a:normAutofit/>
          </a:bodyPr>
          <a:lstStyle/>
          <a:p>
            <a:pPr algn="ctr"/>
            <a:r>
              <a:rPr lang="en-GB" dirty="0"/>
              <a:t>Supplementary online video 1:  Proximal Coronary Ectasia on coronary angiography</a:t>
            </a:r>
          </a:p>
        </p:txBody>
      </p:sp>
      <p:pic>
        <p:nvPicPr>
          <p:cNvPr id="7" name="Anonymize.Ser3">
            <a:hlinkClick r:id="" action="ppaction://media"/>
            <a:extLst>
              <a:ext uri="{FF2B5EF4-FFF2-40B4-BE49-F238E27FC236}">
                <a16:creationId xmlns:a16="http://schemas.microsoft.com/office/drawing/2014/main" id="{8A1C4017-A098-44C2-A93A-9D8317604034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1979085" y="1505570"/>
            <a:ext cx="8096249" cy="4997449"/>
          </a:xfrm>
        </p:spPr>
      </p:pic>
    </p:spTree>
    <p:extLst>
      <p:ext uri="{BB962C8B-B14F-4D97-AF65-F5344CB8AC3E}">
        <p14:creationId xmlns:p14="http://schemas.microsoft.com/office/powerpoint/2010/main" val="221176097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147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Anonymize.Ser7">
            <a:hlinkClick r:id="" action="ppaction://media"/>
            <a:extLst>
              <a:ext uri="{FF2B5EF4-FFF2-40B4-BE49-F238E27FC236}">
                <a16:creationId xmlns:a16="http://schemas.microsoft.com/office/drawing/2014/main" id="{154D32C9-4468-40EE-8FC2-8DDA001CD0CB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5"/>
          <a:srcRect t="-21496" b="-1"/>
          <a:stretch/>
        </p:blipFill>
        <p:spPr>
          <a:xfrm>
            <a:off x="2047875" y="252484"/>
            <a:ext cx="8096249" cy="6071715"/>
          </a:xfrm>
        </p:spPr>
      </p:pic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259307" y="0"/>
            <a:ext cx="11737960" cy="1325563"/>
          </a:xfrm>
        </p:spPr>
        <p:txBody>
          <a:bodyPr>
            <a:normAutofit/>
          </a:bodyPr>
          <a:lstStyle/>
          <a:p>
            <a:pPr algn="ctr"/>
            <a:r>
              <a:rPr lang="en-GB" dirty="0"/>
              <a:t>Supplementary online video 2: Occlusion of Left Anterior Descending (LAD)</a:t>
            </a:r>
          </a:p>
        </p:txBody>
      </p:sp>
    </p:spTree>
    <p:extLst>
      <p:ext uri="{BB962C8B-B14F-4D97-AF65-F5344CB8AC3E}">
        <p14:creationId xmlns:p14="http://schemas.microsoft.com/office/powerpoint/2010/main" val="6380433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279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Anonymize.Ser12">
            <a:hlinkClick r:id="" action="ppaction://media"/>
            <a:extLst>
              <a:ext uri="{FF2B5EF4-FFF2-40B4-BE49-F238E27FC236}">
                <a16:creationId xmlns:a16="http://schemas.microsoft.com/office/drawing/2014/main" id="{A5C0D994-7975-49E1-A884-C8D787809DAF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1999557" y="1325563"/>
            <a:ext cx="8096249" cy="4997449"/>
          </a:xfrm>
        </p:spPr>
      </p:pic>
      <p:sp>
        <p:nvSpPr>
          <p:cNvPr id="3" name="Title 2">
            <a:extLst>
              <a:ext uri="{FF2B5EF4-FFF2-40B4-BE49-F238E27FC236}">
                <a16:creationId xmlns:a16="http://schemas.microsoft.com/office/drawing/2014/main" id="{ACD7561F-4F9C-4460-BDD2-BA304CD53B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38836" y="0"/>
            <a:ext cx="11519670" cy="1325563"/>
          </a:xfrm>
        </p:spPr>
        <p:txBody>
          <a:bodyPr>
            <a:normAutofit/>
          </a:bodyPr>
          <a:lstStyle/>
          <a:p>
            <a:pPr algn="ctr"/>
            <a:r>
              <a:rPr lang="en-GB" dirty="0"/>
              <a:t>Supplementary online video 3: Post clot aspiration and thrombolysis</a:t>
            </a:r>
          </a:p>
        </p:txBody>
      </p:sp>
    </p:spTree>
    <p:extLst>
      <p:ext uri="{BB962C8B-B14F-4D97-AF65-F5344CB8AC3E}">
        <p14:creationId xmlns:p14="http://schemas.microsoft.com/office/powerpoint/2010/main" val="157831481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685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D35A65-FC38-4CE7-965F-4AD8B69A08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GB" dirty="0"/>
              <a:t>Supplementary video 4: Echocardiogram 1-week post-infarction</a:t>
            </a:r>
          </a:p>
        </p:txBody>
      </p:sp>
      <p:pic>
        <p:nvPicPr>
          <p:cNvPr id="7" name="ECHO cropped">
            <a:hlinkClick r:id="" action="ppaction://media"/>
            <a:extLst>
              <a:ext uri="{FF2B5EF4-FFF2-40B4-BE49-F238E27FC236}">
                <a16:creationId xmlns:a16="http://schemas.microsoft.com/office/drawing/2014/main" id="{5FED41F4-C124-4E54-BA03-32DBC8B04195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704798" y="1932508"/>
            <a:ext cx="4782403" cy="34313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812599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712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DB15EDE21EDAC42BEC58CA4BFEAF27C" ma:contentTypeVersion="13" ma:contentTypeDescription="Create a new document." ma:contentTypeScope="" ma:versionID="a088191323c692d2c8201b6afd6d580f">
  <xsd:schema xmlns:xsd="http://www.w3.org/2001/XMLSchema" xmlns:xs="http://www.w3.org/2001/XMLSchema" xmlns:p="http://schemas.microsoft.com/office/2006/metadata/properties" xmlns:ns3="09cfed95-9412-47f5-a07b-8666eb12ebc6" xmlns:ns4="c68fc841-2dac-4615-92e7-fd582c23c8b3" targetNamespace="http://schemas.microsoft.com/office/2006/metadata/properties" ma:root="true" ma:fieldsID="db5ca8d4796cacefe7d910bf539fed4c" ns3:_="" ns4:_="">
    <xsd:import namespace="09cfed95-9412-47f5-a07b-8666eb12ebc6"/>
    <xsd:import namespace="c68fc841-2dac-4615-92e7-fd582c23c8b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9cfed95-9412-47f5-a07b-8666eb12ebc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68fc841-2dac-4615-92e7-fd582c23c8b3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14EE2C59-1A3B-4ABD-8ACA-082906556A3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F67317EE-A435-4133-B83D-E04B91E84C57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0B97766E-917A-459C-A73A-DAFCFF21618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9cfed95-9412-47f5-a07b-8666eb12ebc6"/>
    <ds:schemaRef ds:uri="c68fc841-2dac-4615-92e7-fd582c23c8b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142</Words>
  <Application>Microsoft Office PowerPoint</Application>
  <PresentationFormat>Widescreen</PresentationFormat>
  <Paragraphs>18</Paragraphs>
  <Slides>5</Slides>
  <Notes>3</Notes>
  <HiddenSlides>0</HiddenSlides>
  <MMClips>4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HelveticaNeueLTStd-LtIt</vt:lpstr>
      <vt:lpstr>Office Theme</vt:lpstr>
      <vt:lpstr>Supplementary video files</vt:lpstr>
      <vt:lpstr>Supplementary online video 1:  Proximal Coronary Ectasia on coronary angiography</vt:lpstr>
      <vt:lpstr>Supplementary online video 2: Occlusion of Left Anterior Descending (LAD)</vt:lpstr>
      <vt:lpstr>Supplementary online video 3: Post clot aspiration and thrombolysis</vt:lpstr>
      <vt:lpstr>Supplementary video 4: Echocardiogram 1-week post-infarc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video files</dc:title>
  <dc:creator>Mark Ponsford</dc:creator>
  <cp:lastModifiedBy>Mark Ponsford</cp:lastModifiedBy>
  <cp:revision>4</cp:revision>
  <dcterms:created xsi:type="dcterms:W3CDTF">2020-06-10T11:36:04Z</dcterms:created>
  <dcterms:modified xsi:type="dcterms:W3CDTF">2020-08-28T10:25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DB15EDE21EDAC42BEC58CA4BFEAF27C</vt:lpwstr>
  </property>
</Properties>
</file>